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6" userDrawn="1">
          <p15:clr>
            <a:srgbClr val="A4A3A4"/>
          </p15:clr>
        </p15:guide>
        <p15:guide id="2" pos="1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590"/>
  </p:normalViewPr>
  <p:slideViewPr>
    <p:cSldViewPr snapToGrid="0" snapToObjects="1">
      <p:cViewPr varScale="1">
        <p:scale>
          <a:sx n="59" d="100"/>
          <a:sy n="59" d="100"/>
        </p:scale>
        <p:origin x="2611" y="58"/>
      </p:cViewPr>
      <p:guideLst>
        <p:guide orient="horz" pos="576"/>
        <p:guide pos="1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C440DA-989F-424F-AC98-F8222F9051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4243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3CB4B070-E37E-465E-980E-D2CA8E8BFB8F}"/>
              </a:ext>
            </a:extLst>
          </p:cNvPr>
          <p:cNvSpPr txBox="1"/>
          <p:nvPr/>
        </p:nvSpPr>
        <p:spPr>
          <a:xfrm>
            <a:off x="1072244" y="1837268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CF1F943-CE13-4D96-8F88-2542DAD9F41F}"/>
              </a:ext>
            </a:extLst>
          </p:cNvPr>
          <p:cNvSpPr txBox="1"/>
          <p:nvPr/>
        </p:nvSpPr>
        <p:spPr>
          <a:xfrm>
            <a:off x="1061024" y="1432514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E86AC69-92FE-4554-B21B-53C9643F7AB3}"/>
              </a:ext>
            </a:extLst>
          </p:cNvPr>
          <p:cNvSpPr txBox="1"/>
          <p:nvPr/>
        </p:nvSpPr>
        <p:spPr>
          <a:xfrm>
            <a:off x="1066634" y="1029331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756E450-63AF-41F9-9D9D-296819295CDF}"/>
              </a:ext>
            </a:extLst>
          </p:cNvPr>
          <p:cNvSpPr txBox="1"/>
          <p:nvPr/>
        </p:nvSpPr>
        <p:spPr>
          <a:xfrm>
            <a:off x="1061024" y="627074"/>
            <a:ext cx="659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CB5599A-3467-4CEC-A3FA-2B9F953249FC}"/>
              </a:ext>
            </a:extLst>
          </p:cNvPr>
          <p:cNvSpPr txBox="1"/>
          <p:nvPr/>
        </p:nvSpPr>
        <p:spPr>
          <a:xfrm rot="16200000">
            <a:off x="438559" y="1458746"/>
            <a:ext cx="16729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C-SHP099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A5DB08AC-AFD0-4963-A662-8560A77DF99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929" t="9617" r="27229" b="31824"/>
          <a:stretch/>
        </p:blipFill>
        <p:spPr>
          <a:xfrm>
            <a:off x="1638939" y="596205"/>
            <a:ext cx="1787951" cy="1406766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F3EAF2A8-219B-47CC-B89A-690E4BB21996}"/>
              </a:ext>
            </a:extLst>
          </p:cNvPr>
          <p:cNvSpPr txBox="1"/>
          <p:nvPr/>
        </p:nvSpPr>
        <p:spPr>
          <a:xfrm rot="19917509">
            <a:off x="518899" y="2296529"/>
            <a:ext cx="18862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p 25% sensitive to trametini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41BBEC8-43B4-4AD8-83AB-07D396D2A0C2}"/>
              </a:ext>
            </a:extLst>
          </p:cNvPr>
          <p:cNvSpPr txBox="1"/>
          <p:nvPr/>
        </p:nvSpPr>
        <p:spPr>
          <a:xfrm rot="19767681">
            <a:off x="1218350" y="2360043"/>
            <a:ext cx="2026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ottom 25% sensitive to trametini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6144B45-A4E9-6D4C-97A0-878BB415FF47}"/>
              </a:ext>
            </a:extLst>
          </p:cNvPr>
          <p:cNvSpPr txBox="1"/>
          <p:nvPr/>
        </p:nvSpPr>
        <p:spPr>
          <a:xfrm>
            <a:off x="2336198" y="349984"/>
            <a:ext cx="9239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NS</a:t>
            </a:r>
            <a:endParaRPr kumimoji="0" 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C90F4286-9BCF-6E47-8B84-1C8A6A4334A7}"/>
              </a:ext>
            </a:extLst>
          </p:cNvPr>
          <p:cNvCxnSpPr/>
          <p:nvPr/>
        </p:nvCxnSpPr>
        <p:spPr>
          <a:xfrm>
            <a:off x="2196205" y="536277"/>
            <a:ext cx="831425" cy="75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933069A-8E09-A748-9AD6-886CE8A7C363}"/>
              </a:ext>
            </a:extLst>
          </p:cNvPr>
          <p:cNvCxnSpPr/>
          <p:nvPr/>
        </p:nvCxnSpPr>
        <p:spPr>
          <a:xfrm flipV="1">
            <a:off x="2201704" y="541083"/>
            <a:ext cx="0" cy="1242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0894E6A-6452-3044-97A9-9550A73673D5}"/>
              </a:ext>
            </a:extLst>
          </p:cNvPr>
          <p:cNvCxnSpPr/>
          <p:nvPr/>
        </p:nvCxnSpPr>
        <p:spPr>
          <a:xfrm flipV="1">
            <a:off x="3021654" y="536277"/>
            <a:ext cx="0" cy="1177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E531E4FF-E4D7-449F-8F01-71B1696D4DDC}"/>
              </a:ext>
            </a:extLst>
          </p:cNvPr>
          <p:cNvSpPr txBox="1"/>
          <p:nvPr/>
        </p:nvSpPr>
        <p:spPr>
          <a:xfrm>
            <a:off x="6342" y="2880287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1F05638-1DAD-4A59-9464-CC9E18AD29D2}"/>
              </a:ext>
            </a:extLst>
          </p:cNvPr>
          <p:cNvSpPr txBox="1"/>
          <p:nvPr/>
        </p:nvSpPr>
        <p:spPr>
          <a:xfrm>
            <a:off x="-15266" y="344141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4DC93B4-FD1A-4773-8BD9-D78DFAA6D143}"/>
              </a:ext>
            </a:extLst>
          </p:cNvPr>
          <p:cNvSpPr txBox="1"/>
          <p:nvPr/>
        </p:nvSpPr>
        <p:spPr>
          <a:xfrm>
            <a:off x="1530656" y="4603281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0D2A313-FDCF-42FB-AE9B-91C269FA690B}"/>
              </a:ext>
            </a:extLst>
          </p:cNvPr>
          <p:cNvSpPr txBox="1"/>
          <p:nvPr/>
        </p:nvSpPr>
        <p:spPr>
          <a:xfrm>
            <a:off x="2021824" y="4603281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AF3CD33-52A5-452E-ADFE-609EA3990C23}"/>
              </a:ext>
            </a:extLst>
          </p:cNvPr>
          <p:cNvSpPr txBox="1"/>
          <p:nvPr/>
        </p:nvSpPr>
        <p:spPr>
          <a:xfrm>
            <a:off x="2520815" y="4603281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53FFC79-2750-4B11-9304-B8ADCA2E641D}"/>
              </a:ext>
            </a:extLst>
          </p:cNvPr>
          <p:cNvSpPr txBox="1"/>
          <p:nvPr/>
        </p:nvSpPr>
        <p:spPr>
          <a:xfrm>
            <a:off x="3019804" y="4603281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6FA9EAE-612D-41AD-85DD-CB9900698833}"/>
              </a:ext>
            </a:extLst>
          </p:cNvPr>
          <p:cNvSpPr txBox="1"/>
          <p:nvPr/>
        </p:nvSpPr>
        <p:spPr>
          <a:xfrm>
            <a:off x="3458686" y="4603281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.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AC6B278-61FB-4FBA-A31A-1DAC26A4F9EE}"/>
              </a:ext>
            </a:extLst>
          </p:cNvPr>
          <p:cNvSpPr txBox="1"/>
          <p:nvPr/>
        </p:nvSpPr>
        <p:spPr>
          <a:xfrm>
            <a:off x="2276775" y="4890874"/>
            <a:ext cx="974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UC-</a:t>
            </a:r>
            <a:r>
              <a:rPr kumimoji="0" lang="en-US" sz="10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lpelisib</a:t>
            </a:r>
            <a:endParaRPr kumimoji="0" 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4FD6ABA-7731-45C3-9291-F02FAC51A484}"/>
              </a:ext>
            </a:extLst>
          </p:cNvPr>
          <p:cNvSpPr txBox="1"/>
          <p:nvPr/>
        </p:nvSpPr>
        <p:spPr>
          <a:xfrm rot="16200000">
            <a:off x="827668" y="3946336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UC-SHP099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27C886A-7BE3-485C-A1E1-F1C47729E248}"/>
              </a:ext>
            </a:extLst>
          </p:cNvPr>
          <p:cNvSpPr txBox="1"/>
          <p:nvPr/>
        </p:nvSpPr>
        <p:spPr>
          <a:xfrm>
            <a:off x="1387093" y="446750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C489A68-D25E-434C-9A12-667EA6633A6C}"/>
              </a:ext>
            </a:extLst>
          </p:cNvPr>
          <p:cNvSpPr txBox="1"/>
          <p:nvPr/>
        </p:nvSpPr>
        <p:spPr>
          <a:xfrm>
            <a:off x="1387093" y="425406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8E03A91-CA27-43B2-A475-88F3A7133EC4}"/>
              </a:ext>
            </a:extLst>
          </p:cNvPr>
          <p:cNvSpPr txBox="1"/>
          <p:nvPr/>
        </p:nvSpPr>
        <p:spPr>
          <a:xfrm>
            <a:off x="1387093" y="404843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B1B8ACE-B4DD-47B6-AB48-390928029CB8}"/>
              </a:ext>
            </a:extLst>
          </p:cNvPr>
          <p:cNvSpPr txBox="1"/>
          <p:nvPr/>
        </p:nvSpPr>
        <p:spPr>
          <a:xfrm>
            <a:off x="1387093" y="383499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FD694F6-0E93-4133-A20C-BAE6ED5F5727}"/>
              </a:ext>
            </a:extLst>
          </p:cNvPr>
          <p:cNvSpPr txBox="1"/>
          <p:nvPr/>
        </p:nvSpPr>
        <p:spPr>
          <a:xfrm>
            <a:off x="1387093" y="362937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75E4181-C69F-4555-8B64-E68166A3208F}"/>
              </a:ext>
            </a:extLst>
          </p:cNvPr>
          <p:cNvSpPr txBox="1"/>
          <p:nvPr/>
        </p:nvSpPr>
        <p:spPr>
          <a:xfrm>
            <a:off x="1718162" y="4336374"/>
            <a:ext cx="2098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</a:t>
            </a:r>
            <a:r>
              <a:rPr kumimoji="0" lang="en-US" sz="10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-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=0.005398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6E10117-8D13-474C-87C1-03C3D7770D1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33311" t="50000" r="7973" b="11092"/>
          <a:stretch/>
        </p:blipFill>
        <p:spPr>
          <a:xfrm>
            <a:off x="1687402" y="3504939"/>
            <a:ext cx="2075688" cy="1135036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9265BE1D-FE68-4B96-AF79-255459729EFA}"/>
              </a:ext>
            </a:extLst>
          </p:cNvPr>
          <p:cNvSpPr txBox="1"/>
          <p:nvPr/>
        </p:nvSpPr>
        <p:spPr>
          <a:xfrm>
            <a:off x="1390999" y="3414459"/>
            <a:ext cx="360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.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90A5A08-F0B8-FBC1-D833-12AF82B67154}"/>
              </a:ext>
            </a:extLst>
          </p:cNvPr>
          <p:cNvSpPr txBox="1"/>
          <p:nvPr/>
        </p:nvSpPr>
        <p:spPr>
          <a:xfrm>
            <a:off x="10144" y="5355459"/>
            <a:ext cx="6609806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NSCC tumor cell lines are effective to SHP099 through dual PI3K and MEK inhibition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) HNSCC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lines screened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s part of the GDSC screening campaign were clustered into the bottom and top 25% by sensitivity to Trametinib, and the SHP099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ea under the curve (AUC)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for these cell lines were plotted. The red bars indicate the means of each group. Statistical significance was determined using two-tailed Student’s t-test, p value= not significant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Area under the curve (AUC) for SHP099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pelisib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reated HNSCC cell lines were plotted to assess potential correlation in sensitivities. Correlation analysis was performed using Spearman correlation, p value = not significant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6261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45</TotalTime>
  <Words>168</Words>
  <Application>Microsoft Office PowerPoint</Application>
  <PresentationFormat>On-screen Show (4:3)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352</cp:revision>
  <cp:lastPrinted>2019-09-23T20:12:05Z</cp:lastPrinted>
  <dcterms:created xsi:type="dcterms:W3CDTF">2019-03-07T03:13:48Z</dcterms:created>
  <dcterms:modified xsi:type="dcterms:W3CDTF">2022-07-07T10:32:39Z</dcterms:modified>
</cp:coreProperties>
</file>